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353" r:id="rId2"/>
    <p:sldId id="354" r:id="rId3"/>
    <p:sldId id="338" r:id="rId4"/>
  </p:sldIdLst>
  <p:sldSz cx="9144000" cy="6858000" type="screen4x3"/>
  <p:notesSz cx="6742113" cy="98758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87" userDrawn="1">
          <p15:clr>
            <a:srgbClr val="A4A3A4"/>
          </p15:clr>
        </p15:guide>
        <p15:guide id="2" pos="13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505" autoAdjust="0"/>
    <p:restoredTop sz="94660"/>
  </p:normalViewPr>
  <p:slideViewPr>
    <p:cSldViewPr snapToGrid="0" showGuides="1">
      <p:cViewPr varScale="1">
        <p:scale>
          <a:sx n="112" d="100"/>
          <a:sy n="112" d="100"/>
        </p:scale>
        <p:origin x="1362" y="96"/>
      </p:cViewPr>
      <p:guideLst>
        <p:guide orient="horz" pos="187"/>
        <p:guide pos="13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21582" cy="49550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8971" y="0"/>
            <a:ext cx="2921582" cy="49550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1B8CC37-2044-4EAA-8EBA-40A7C14B25F6}" type="datetimeFigureOut">
              <a:rPr kumimoji="1" lang="ja-JP" altLang="en-US" smtClean="0"/>
              <a:t>2024/7/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50938" y="1235075"/>
            <a:ext cx="4440237" cy="33321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4212" y="4752747"/>
            <a:ext cx="5393690" cy="388861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80333"/>
            <a:ext cx="2921582" cy="49550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8971" y="9380333"/>
            <a:ext cx="2921582" cy="49550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8F165F4-DDF7-4D33-8286-9B4DE4FE12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39736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39AE833-3507-4E5B-B434-A81B2704E3F0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72116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82B5F1-EE75-41A9-B602-725583B7B068}" type="datetimeFigureOut">
              <a:rPr kumimoji="1" lang="ja-JP" altLang="en-US" smtClean="0"/>
              <a:t>2024/7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F11BF7-C4D1-43DD-9362-4B21C4F58B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25437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82B5F1-EE75-41A9-B602-725583B7B068}" type="datetimeFigureOut">
              <a:rPr kumimoji="1" lang="ja-JP" altLang="en-US" smtClean="0"/>
              <a:t>2024/7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F11BF7-C4D1-43DD-9362-4B21C4F58B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59526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82B5F1-EE75-41A9-B602-725583B7B068}" type="datetimeFigureOut">
              <a:rPr kumimoji="1" lang="ja-JP" altLang="en-US" smtClean="0"/>
              <a:t>2024/7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F11BF7-C4D1-43DD-9362-4B21C4F58B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33980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82B5F1-EE75-41A9-B602-725583B7B068}" type="datetimeFigureOut">
              <a:rPr kumimoji="1" lang="ja-JP" altLang="en-US" smtClean="0"/>
              <a:t>2024/7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F11BF7-C4D1-43DD-9362-4B21C4F58B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35269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82B5F1-EE75-41A9-B602-725583B7B068}" type="datetimeFigureOut">
              <a:rPr kumimoji="1" lang="ja-JP" altLang="en-US" smtClean="0"/>
              <a:t>2024/7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F11BF7-C4D1-43DD-9362-4B21C4F58B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72523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82B5F1-EE75-41A9-B602-725583B7B068}" type="datetimeFigureOut">
              <a:rPr kumimoji="1" lang="ja-JP" altLang="en-US" smtClean="0"/>
              <a:t>2024/7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F11BF7-C4D1-43DD-9362-4B21C4F58B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8784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82B5F1-EE75-41A9-B602-725583B7B068}" type="datetimeFigureOut">
              <a:rPr kumimoji="1" lang="ja-JP" altLang="en-US" smtClean="0"/>
              <a:t>2024/7/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F11BF7-C4D1-43DD-9362-4B21C4F58B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21492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82B5F1-EE75-41A9-B602-725583B7B068}" type="datetimeFigureOut">
              <a:rPr kumimoji="1" lang="ja-JP" altLang="en-US" smtClean="0"/>
              <a:t>2024/7/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F11BF7-C4D1-43DD-9362-4B21C4F58B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0603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82B5F1-EE75-41A9-B602-725583B7B068}" type="datetimeFigureOut">
              <a:rPr kumimoji="1" lang="ja-JP" altLang="en-US" smtClean="0"/>
              <a:t>2024/7/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F11BF7-C4D1-43DD-9362-4B21C4F58B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95369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82B5F1-EE75-41A9-B602-725583B7B068}" type="datetimeFigureOut">
              <a:rPr kumimoji="1" lang="ja-JP" altLang="en-US" smtClean="0"/>
              <a:t>2024/7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F11BF7-C4D1-43DD-9362-4B21C4F58B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25784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82B5F1-EE75-41A9-B602-725583B7B068}" type="datetimeFigureOut">
              <a:rPr kumimoji="1" lang="ja-JP" altLang="en-US" smtClean="0"/>
              <a:t>2024/7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F11BF7-C4D1-43DD-9362-4B21C4F58B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33677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982B5F1-EE75-41A9-B602-725583B7B068}" type="datetimeFigureOut">
              <a:rPr kumimoji="1" lang="ja-JP" altLang="en-US" smtClean="0"/>
              <a:t>2024/7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4F11BF7-C4D1-43DD-9362-4B21C4F58B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7738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図 7">
            <a:extLst>
              <a:ext uri="{FF2B5EF4-FFF2-40B4-BE49-F238E27FC236}">
                <a16:creationId xmlns:a16="http://schemas.microsoft.com/office/drawing/2014/main" id="{99D96DA1-666A-A622-D355-8EF91EAC846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7500" r="18108"/>
          <a:stretch/>
        </p:blipFill>
        <p:spPr>
          <a:xfrm>
            <a:off x="4220961" y="1436675"/>
            <a:ext cx="2133359" cy="2217328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F1A06DE6-A8DE-4806-EEA3-7EC96EA11F4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6043" r="14821"/>
          <a:stretch/>
        </p:blipFill>
        <p:spPr>
          <a:xfrm>
            <a:off x="1555349" y="1446553"/>
            <a:ext cx="2290520" cy="2217328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56C43130-25EB-1850-DB92-E886F9E965B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8630" r="17519"/>
          <a:stretch/>
        </p:blipFill>
        <p:spPr>
          <a:xfrm>
            <a:off x="6729412" y="1482273"/>
            <a:ext cx="2081367" cy="2181608"/>
          </a:xfrm>
          <a:prstGeom prst="rect">
            <a:avLst/>
          </a:prstGeom>
        </p:spPr>
      </p:pic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CF2D4288-EAF9-330D-836E-CCE4595CA66F}"/>
              </a:ext>
            </a:extLst>
          </p:cNvPr>
          <p:cNvSpPr txBox="1"/>
          <p:nvPr/>
        </p:nvSpPr>
        <p:spPr>
          <a:xfrm>
            <a:off x="212323" y="2573077"/>
            <a:ext cx="1343025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ja-JP" altLang="en-US" sz="1600" dirty="0"/>
              <a:t>Control</a:t>
            </a:r>
          </a:p>
        </p:txBody>
      </p:sp>
      <p:pic>
        <p:nvPicPr>
          <p:cNvPr id="16" name="図 15">
            <a:extLst>
              <a:ext uri="{FF2B5EF4-FFF2-40B4-BE49-F238E27FC236}">
                <a16:creationId xmlns:a16="http://schemas.microsoft.com/office/drawing/2014/main" id="{891EED70-520E-0C82-B7C7-077FEA5136B5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8675" t="10386" r="17763"/>
          <a:stretch/>
        </p:blipFill>
        <p:spPr>
          <a:xfrm>
            <a:off x="1635918" y="3937379"/>
            <a:ext cx="2121695" cy="2001994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E9FA44B1-A7C2-4052-9A25-6CA2D1996568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9240" t="11345" r="19124"/>
          <a:stretch/>
        </p:blipFill>
        <p:spPr>
          <a:xfrm>
            <a:off x="4279102" y="3937379"/>
            <a:ext cx="2057402" cy="1980563"/>
          </a:xfrm>
          <a:prstGeom prst="rect">
            <a:avLst/>
          </a:prstGeom>
        </p:spPr>
      </p:pic>
      <p:pic>
        <p:nvPicPr>
          <p:cNvPr id="19" name="図 18">
            <a:extLst>
              <a:ext uri="{FF2B5EF4-FFF2-40B4-BE49-F238E27FC236}">
                <a16:creationId xmlns:a16="http://schemas.microsoft.com/office/drawing/2014/main" id="{5AC209DA-C63B-7611-24C0-280C8E2224EF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7413" t="9711" r="16564"/>
          <a:stretch/>
        </p:blipFill>
        <p:spPr>
          <a:xfrm>
            <a:off x="6672261" y="3927843"/>
            <a:ext cx="2185987" cy="2001995"/>
          </a:xfrm>
          <a:prstGeom prst="rect">
            <a:avLst/>
          </a:prstGeom>
        </p:spPr>
      </p:pic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B52C5BD7-54DE-672F-C0E0-7B11A8B4121C}"/>
              </a:ext>
            </a:extLst>
          </p:cNvPr>
          <p:cNvSpPr txBox="1"/>
          <p:nvPr/>
        </p:nvSpPr>
        <p:spPr>
          <a:xfrm>
            <a:off x="-26992" y="4636509"/>
            <a:ext cx="1821656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ja-JP" altLang="en-US" sz="1600" dirty="0"/>
              <a:t>Limonite</a:t>
            </a:r>
          </a:p>
        </p:txBody>
      </p:sp>
      <p:grpSp>
        <p:nvGrpSpPr>
          <p:cNvPr id="35" name="グループ化 34">
            <a:extLst>
              <a:ext uri="{FF2B5EF4-FFF2-40B4-BE49-F238E27FC236}">
                <a16:creationId xmlns:a16="http://schemas.microsoft.com/office/drawing/2014/main" id="{9DA92381-C469-093C-9DBA-5D84617CEC9E}"/>
              </a:ext>
            </a:extLst>
          </p:cNvPr>
          <p:cNvGrpSpPr/>
          <p:nvPr/>
        </p:nvGrpSpPr>
        <p:grpSpPr>
          <a:xfrm>
            <a:off x="1511450" y="6123097"/>
            <a:ext cx="1821656" cy="276999"/>
            <a:chOff x="1141010" y="6098788"/>
            <a:chExt cx="1821656" cy="276999"/>
          </a:xfrm>
        </p:grpSpPr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1099B9BF-8460-13FE-B7C4-4ABBD9F64E28}"/>
                </a:ext>
              </a:extLst>
            </p:cNvPr>
            <p:cNvSpPr txBox="1"/>
            <p:nvPr/>
          </p:nvSpPr>
          <p:spPr>
            <a:xfrm>
              <a:off x="1141010" y="6098788"/>
              <a:ext cx="1821656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200" dirty="0"/>
                <a:t>Oral bacteria</a:t>
              </a:r>
              <a:endParaRPr lang="ja-JP" altLang="en-US" sz="1200" dirty="0"/>
            </a:p>
          </p:txBody>
        </p:sp>
        <p:sp>
          <p:nvSpPr>
            <p:cNvPr id="28" name="正方形/長方形 27">
              <a:extLst>
                <a:ext uri="{FF2B5EF4-FFF2-40B4-BE49-F238E27FC236}">
                  <a16:creationId xmlns:a16="http://schemas.microsoft.com/office/drawing/2014/main" id="{E38C6D32-662C-A607-AB36-9F7F80F8436E}"/>
                </a:ext>
              </a:extLst>
            </p:cNvPr>
            <p:cNvSpPr/>
            <p:nvPr/>
          </p:nvSpPr>
          <p:spPr>
            <a:xfrm>
              <a:off x="1448290" y="6167590"/>
              <a:ext cx="140016" cy="123494"/>
            </a:xfrm>
            <a:prstGeom prst="rect">
              <a:avLst/>
            </a:prstGeom>
            <a:solidFill>
              <a:schemeClr val="tx2">
                <a:lumMod val="75000"/>
                <a:lumOff val="2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34" name="グループ化 33">
            <a:extLst>
              <a:ext uri="{FF2B5EF4-FFF2-40B4-BE49-F238E27FC236}">
                <a16:creationId xmlns:a16="http://schemas.microsoft.com/office/drawing/2014/main" id="{E1EDEF3C-045E-273D-CD6D-71228AD78AF9}"/>
              </a:ext>
            </a:extLst>
          </p:cNvPr>
          <p:cNvGrpSpPr/>
          <p:nvPr/>
        </p:nvGrpSpPr>
        <p:grpSpPr>
          <a:xfrm>
            <a:off x="3067205" y="6123096"/>
            <a:ext cx="1821656" cy="276999"/>
            <a:chOff x="2696765" y="6090838"/>
            <a:chExt cx="1821656" cy="276999"/>
          </a:xfrm>
        </p:grpSpPr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42E6D184-C393-4A25-A773-7AE1B606BA90}"/>
                </a:ext>
              </a:extLst>
            </p:cNvPr>
            <p:cNvSpPr txBox="1"/>
            <p:nvPr/>
          </p:nvSpPr>
          <p:spPr>
            <a:xfrm>
              <a:off x="2696765" y="6090838"/>
              <a:ext cx="1821656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200" dirty="0"/>
                <a:t>Rumen bacteria</a:t>
              </a:r>
              <a:endParaRPr lang="ja-JP" altLang="en-US" sz="1200" dirty="0"/>
            </a:p>
          </p:txBody>
        </p:sp>
        <p:sp>
          <p:nvSpPr>
            <p:cNvPr id="29" name="正方形/長方形 28">
              <a:extLst>
                <a:ext uri="{FF2B5EF4-FFF2-40B4-BE49-F238E27FC236}">
                  <a16:creationId xmlns:a16="http://schemas.microsoft.com/office/drawing/2014/main" id="{DDAE5ADA-372D-5167-7B73-FCBAE76C1CA3}"/>
                </a:ext>
              </a:extLst>
            </p:cNvPr>
            <p:cNvSpPr/>
            <p:nvPr/>
          </p:nvSpPr>
          <p:spPr>
            <a:xfrm>
              <a:off x="2913674" y="6167590"/>
              <a:ext cx="140016" cy="123494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33" name="グループ化 32">
            <a:extLst>
              <a:ext uri="{FF2B5EF4-FFF2-40B4-BE49-F238E27FC236}">
                <a16:creationId xmlns:a16="http://schemas.microsoft.com/office/drawing/2014/main" id="{FAB80095-C909-FA50-B375-09CE2D993FF4}"/>
              </a:ext>
            </a:extLst>
          </p:cNvPr>
          <p:cNvGrpSpPr/>
          <p:nvPr/>
        </p:nvGrpSpPr>
        <p:grpSpPr>
          <a:xfrm>
            <a:off x="4903104" y="6123097"/>
            <a:ext cx="1821656" cy="276999"/>
            <a:chOff x="4514848" y="6098788"/>
            <a:chExt cx="1821656" cy="276999"/>
          </a:xfrm>
        </p:grpSpPr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188F97EA-08F7-CA20-619D-6772F2F401CD}"/>
                </a:ext>
              </a:extLst>
            </p:cNvPr>
            <p:cNvSpPr txBox="1"/>
            <p:nvPr/>
          </p:nvSpPr>
          <p:spPr>
            <a:xfrm>
              <a:off x="4514848" y="6098788"/>
              <a:ext cx="1821656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200" dirty="0"/>
                <a:t>Core rumen bacteria</a:t>
              </a:r>
              <a:endParaRPr lang="ja-JP" altLang="en-US" sz="1200" dirty="0"/>
            </a:p>
          </p:txBody>
        </p:sp>
        <p:sp>
          <p:nvSpPr>
            <p:cNvPr id="30" name="正方形/長方形 29">
              <a:extLst>
                <a:ext uri="{FF2B5EF4-FFF2-40B4-BE49-F238E27FC236}">
                  <a16:creationId xmlns:a16="http://schemas.microsoft.com/office/drawing/2014/main" id="{6B66DEAD-B9A6-2EA4-D1A5-1174D2809BAB}"/>
                </a:ext>
              </a:extLst>
            </p:cNvPr>
            <p:cNvSpPr/>
            <p:nvPr/>
          </p:nvSpPr>
          <p:spPr>
            <a:xfrm>
              <a:off x="4572000" y="6167590"/>
              <a:ext cx="140016" cy="123494"/>
            </a:xfrm>
            <a:prstGeom prst="rect">
              <a:avLst/>
            </a:prstGeom>
            <a:solidFill>
              <a:schemeClr val="accent3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32" name="グループ化 31">
            <a:extLst>
              <a:ext uri="{FF2B5EF4-FFF2-40B4-BE49-F238E27FC236}">
                <a16:creationId xmlns:a16="http://schemas.microsoft.com/office/drawing/2014/main" id="{82DDE530-5A7D-3B91-00E8-761258397102}"/>
              </a:ext>
            </a:extLst>
          </p:cNvPr>
          <p:cNvGrpSpPr/>
          <p:nvPr/>
        </p:nvGrpSpPr>
        <p:grpSpPr>
          <a:xfrm>
            <a:off x="6919115" y="6123097"/>
            <a:ext cx="1891664" cy="276999"/>
            <a:chOff x="6784418" y="6098788"/>
            <a:chExt cx="1891664" cy="276999"/>
          </a:xfrm>
        </p:grpSpPr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C65C5005-8CB9-FCF3-5C07-6334FBED126C}"/>
                </a:ext>
              </a:extLst>
            </p:cNvPr>
            <p:cNvSpPr txBox="1"/>
            <p:nvPr/>
          </p:nvSpPr>
          <p:spPr>
            <a:xfrm>
              <a:off x="6854426" y="6098788"/>
              <a:ext cx="1821656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200" dirty="0"/>
                <a:t>Noncore rumen bacteria</a:t>
              </a:r>
              <a:endParaRPr lang="ja-JP" altLang="en-US" sz="1200" dirty="0"/>
            </a:p>
          </p:txBody>
        </p:sp>
        <p:sp>
          <p:nvSpPr>
            <p:cNvPr id="31" name="正方形/長方形 30">
              <a:extLst>
                <a:ext uri="{FF2B5EF4-FFF2-40B4-BE49-F238E27FC236}">
                  <a16:creationId xmlns:a16="http://schemas.microsoft.com/office/drawing/2014/main" id="{298AD78A-039C-A9C3-1991-3587F62A9FAA}"/>
                </a:ext>
              </a:extLst>
            </p:cNvPr>
            <p:cNvSpPr/>
            <p:nvPr/>
          </p:nvSpPr>
          <p:spPr>
            <a:xfrm>
              <a:off x="6784418" y="6175541"/>
              <a:ext cx="140016" cy="123494"/>
            </a:xfrm>
            <a:prstGeom prst="rect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>
                <a:highlight>
                  <a:srgbClr val="FFFF00"/>
                </a:highlight>
              </a:endParaRPr>
            </a:p>
          </p:txBody>
        </p:sp>
      </p:grp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982DEB59-9D58-EA54-950B-A25DF9D5A372}"/>
              </a:ext>
            </a:extLst>
          </p:cNvPr>
          <p:cNvSpPr txBox="1"/>
          <p:nvPr/>
        </p:nvSpPr>
        <p:spPr>
          <a:xfrm>
            <a:off x="423388" y="85690"/>
            <a:ext cx="997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</a:rPr>
              <a:t>Figure S</a:t>
            </a:r>
            <a:r>
              <a:rPr lang="ja-JP" altLang="en-US" sz="1200" b="1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</a:rPr>
              <a:t>１</a:t>
            </a:r>
            <a:r>
              <a:rPr lang="en-US" altLang="ja-JP" sz="1200" b="1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</a:rPr>
              <a:t>A.</a:t>
            </a:r>
            <a:endParaRPr kumimoji="1" lang="ja-JP" altLang="en-US" sz="1200" dirty="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D2BF615-01C2-A2D1-8A54-A546FBE4CC7A}"/>
              </a:ext>
            </a:extLst>
          </p:cNvPr>
          <p:cNvSpPr txBox="1"/>
          <p:nvPr/>
        </p:nvSpPr>
        <p:spPr>
          <a:xfrm>
            <a:off x="2018878" y="1416203"/>
            <a:ext cx="1343025" cy="338554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altLang="ja-JP" sz="1600" dirty="0"/>
              <a:t>30</a:t>
            </a:r>
            <a:r>
              <a:rPr lang="ja-JP" altLang="en-US" sz="1600" dirty="0"/>
              <a:t> </a:t>
            </a:r>
            <a:r>
              <a:rPr lang="en-US" altLang="ja-JP" sz="1600" dirty="0"/>
              <a:t>days</a:t>
            </a:r>
            <a:endParaRPr lang="ja-JP" altLang="en-US" sz="1600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8B294F1-E2FD-FA2F-E615-9204673100EF}"/>
              </a:ext>
            </a:extLst>
          </p:cNvPr>
          <p:cNvSpPr txBox="1"/>
          <p:nvPr/>
        </p:nvSpPr>
        <p:spPr>
          <a:xfrm>
            <a:off x="4659824" y="1416203"/>
            <a:ext cx="1343025" cy="338554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altLang="ja-JP" sz="1600" dirty="0"/>
              <a:t>60</a:t>
            </a:r>
            <a:r>
              <a:rPr lang="ja-JP" altLang="en-US" sz="1600" dirty="0"/>
              <a:t> </a:t>
            </a:r>
            <a:r>
              <a:rPr lang="en-US" altLang="ja-JP" sz="1600" dirty="0"/>
              <a:t>days</a:t>
            </a:r>
            <a:endParaRPr lang="ja-JP" altLang="en-US" sz="1600" dirty="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4953505-9CEC-6B73-DC9B-76ABB4B042DF}"/>
              </a:ext>
            </a:extLst>
          </p:cNvPr>
          <p:cNvSpPr txBox="1"/>
          <p:nvPr/>
        </p:nvSpPr>
        <p:spPr>
          <a:xfrm>
            <a:off x="7100967" y="1439014"/>
            <a:ext cx="1343025" cy="338554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altLang="ja-JP" sz="1600" dirty="0"/>
              <a:t>90</a:t>
            </a:r>
            <a:r>
              <a:rPr lang="ja-JP" altLang="en-US" sz="1600" dirty="0"/>
              <a:t> </a:t>
            </a:r>
            <a:r>
              <a:rPr lang="en-US" altLang="ja-JP" sz="1600" dirty="0"/>
              <a:t>days</a:t>
            </a:r>
            <a:endParaRPr lang="ja-JP" altLang="en-US" sz="1600" dirty="0"/>
          </a:p>
        </p:txBody>
      </p:sp>
    </p:spTree>
    <p:extLst>
      <p:ext uri="{BB962C8B-B14F-4D97-AF65-F5344CB8AC3E}">
        <p14:creationId xmlns:p14="http://schemas.microsoft.com/office/powerpoint/2010/main" val="13913745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E8FEBCDE-A78F-8B8B-E5FB-2ED40645D5DA}"/>
              </a:ext>
            </a:extLst>
          </p:cNvPr>
          <p:cNvSpPr txBox="1"/>
          <p:nvPr/>
        </p:nvSpPr>
        <p:spPr>
          <a:xfrm>
            <a:off x="104621" y="69841"/>
            <a:ext cx="9898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</a:rPr>
              <a:t>Figure S</a:t>
            </a:r>
            <a:r>
              <a:rPr lang="ja-JP" altLang="en-US" sz="1200" b="1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</a:rPr>
              <a:t>１</a:t>
            </a:r>
            <a:r>
              <a:rPr lang="en-US" altLang="ja-JP" sz="1200" b="1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</a:rPr>
              <a:t>B.</a:t>
            </a:r>
            <a:endParaRPr kumimoji="1" lang="ja-JP" altLang="en-US" sz="1200" dirty="0"/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73297A0E-6E7B-F891-E724-CDD0E8B2727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5427" y="3635485"/>
            <a:ext cx="2845110" cy="2276087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3B250F3B-7896-634E-BB94-13292CDAAA4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17176" y="3635928"/>
            <a:ext cx="2843999" cy="2275200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114EBDF1-D8C5-40D0-237C-8C84D340767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55595" y="3635928"/>
            <a:ext cx="2843999" cy="2275200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83D492BA-9523-614C-87C2-DC250CCB308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1498" y="935415"/>
            <a:ext cx="2923199" cy="2088000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EBEDEF45-E54E-F9D0-D191-0778167758D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155595" y="885146"/>
            <a:ext cx="3007054" cy="2147895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F93ACAAA-0849-F25B-6F3E-5EF0E87B339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198024" y="885146"/>
            <a:ext cx="3036005" cy="2168575"/>
          </a:xfrm>
          <a:prstGeom prst="rect">
            <a:avLst/>
          </a:prstGeom>
        </p:spPr>
      </p:pic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A6F37B24-24CC-06D9-C962-2E5D97DDE165}"/>
              </a:ext>
            </a:extLst>
          </p:cNvPr>
          <p:cNvSpPr txBox="1"/>
          <p:nvPr/>
        </p:nvSpPr>
        <p:spPr>
          <a:xfrm>
            <a:off x="161498" y="3053721"/>
            <a:ext cx="171735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u="sng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Wilcoxon analysis</a:t>
            </a:r>
            <a:endParaRPr lang="ja-JP" altLang="en-US" sz="1200" u="sng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AEBB0821-2DA7-7369-BE63-3951E111F3FE}"/>
              </a:ext>
            </a:extLst>
          </p:cNvPr>
          <p:cNvSpPr txBox="1"/>
          <p:nvPr/>
        </p:nvSpPr>
        <p:spPr>
          <a:xfrm>
            <a:off x="161498" y="585959"/>
            <a:ext cx="152400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u="sng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</a:t>
            </a:r>
            <a:r>
              <a:rPr lang="en-US" altLang="ja-JP" sz="1200" u="sng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gression analysis</a:t>
            </a:r>
            <a:endParaRPr lang="ja-JP" altLang="en-US" sz="1200" u="sng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36032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コンテンツ プレースホルダー 7">
            <a:extLst>
              <a:ext uri="{FF2B5EF4-FFF2-40B4-BE49-F238E27FC236}">
                <a16:creationId xmlns:a16="http://schemas.microsoft.com/office/drawing/2014/main" id="{FF0D9135-53EC-0173-6592-1348EC9FC84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3"/>
          <a:srcRect l="1001" t="33673" r="25500" b="9351"/>
          <a:stretch/>
        </p:blipFill>
        <p:spPr>
          <a:xfrm>
            <a:off x="524154" y="2000661"/>
            <a:ext cx="8229600" cy="3429001"/>
          </a:xfrm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74E7198E-E4C3-76BD-3AF6-1808B709F125}"/>
              </a:ext>
            </a:extLst>
          </p:cNvPr>
          <p:cNvSpPr txBox="1"/>
          <p:nvPr/>
        </p:nvSpPr>
        <p:spPr>
          <a:xfrm>
            <a:off x="549896" y="1988840"/>
            <a:ext cx="49725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900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B3CB9240-E4F0-7E74-7F1A-AA50F4A082DA}"/>
              </a:ext>
            </a:extLst>
          </p:cNvPr>
          <p:cNvSpPr txBox="1"/>
          <p:nvPr/>
        </p:nvSpPr>
        <p:spPr>
          <a:xfrm>
            <a:off x="549896" y="2307650"/>
            <a:ext cx="49725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8</a:t>
            </a:r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0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E09CC595-BC34-68CF-749F-88CD0790955B}"/>
              </a:ext>
            </a:extLst>
          </p:cNvPr>
          <p:cNvSpPr txBox="1"/>
          <p:nvPr/>
        </p:nvSpPr>
        <p:spPr>
          <a:xfrm>
            <a:off x="549896" y="2667690"/>
            <a:ext cx="49725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700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1A381B75-327F-22D7-0ABE-883D352CDF1C}"/>
              </a:ext>
            </a:extLst>
          </p:cNvPr>
          <p:cNvSpPr txBox="1"/>
          <p:nvPr/>
        </p:nvSpPr>
        <p:spPr>
          <a:xfrm>
            <a:off x="549896" y="3027730"/>
            <a:ext cx="49725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6</a:t>
            </a:r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0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FE033279-FB26-630E-9E79-5BB02F1BE1F3}"/>
              </a:ext>
            </a:extLst>
          </p:cNvPr>
          <p:cNvSpPr txBox="1"/>
          <p:nvPr/>
        </p:nvSpPr>
        <p:spPr>
          <a:xfrm>
            <a:off x="549896" y="3315762"/>
            <a:ext cx="49725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500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9B9AAE15-EF56-254C-B505-87B2782D3543}"/>
              </a:ext>
            </a:extLst>
          </p:cNvPr>
          <p:cNvSpPr txBox="1"/>
          <p:nvPr/>
        </p:nvSpPr>
        <p:spPr>
          <a:xfrm>
            <a:off x="549896" y="3654316"/>
            <a:ext cx="49725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4</a:t>
            </a:r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0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6BDA8D69-25C2-A4BC-0326-F4912134D8F3}"/>
              </a:ext>
            </a:extLst>
          </p:cNvPr>
          <p:cNvSpPr txBox="1"/>
          <p:nvPr/>
        </p:nvSpPr>
        <p:spPr>
          <a:xfrm>
            <a:off x="549896" y="3963834"/>
            <a:ext cx="49725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300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B2A66735-CD04-517C-3D21-6A7CCE51FC87}"/>
              </a:ext>
            </a:extLst>
          </p:cNvPr>
          <p:cNvSpPr txBox="1"/>
          <p:nvPr/>
        </p:nvSpPr>
        <p:spPr>
          <a:xfrm>
            <a:off x="549896" y="4251866"/>
            <a:ext cx="49725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</a:t>
            </a:r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0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C5BE8E78-B6E9-29CB-825B-88E9264A0E49}"/>
              </a:ext>
            </a:extLst>
          </p:cNvPr>
          <p:cNvSpPr txBox="1"/>
          <p:nvPr/>
        </p:nvSpPr>
        <p:spPr>
          <a:xfrm>
            <a:off x="549896" y="4611906"/>
            <a:ext cx="49725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00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1ED1D10D-AFA1-04C1-09D4-6AA2C49F2472}"/>
              </a:ext>
            </a:extLst>
          </p:cNvPr>
          <p:cNvSpPr txBox="1"/>
          <p:nvPr/>
        </p:nvSpPr>
        <p:spPr>
          <a:xfrm>
            <a:off x="693912" y="4950460"/>
            <a:ext cx="28886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E04A50F3-BB9A-1C4F-D5B5-608E26D7224A}"/>
              </a:ext>
            </a:extLst>
          </p:cNvPr>
          <p:cNvSpPr txBox="1"/>
          <p:nvPr/>
        </p:nvSpPr>
        <p:spPr>
          <a:xfrm>
            <a:off x="981944" y="5115962"/>
            <a:ext cx="287202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D700E5E4-E717-0749-FA58-96E4CAC495B1}"/>
              </a:ext>
            </a:extLst>
          </p:cNvPr>
          <p:cNvSpPr txBox="1"/>
          <p:nvPr/>
        </p:nvSpPr>
        <p:spPr>
          <a:xfrm>
            <a:off x="1558008" y="5115962"/>
            <a:ext cx="28886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70866E01-5E6E-8E11-A265-704CF05B7AA4}"/>
              </a:ext>
            </a:extLst>
          </p:cNvPr>
          <p:cNvSpPr txBox="1"/>
          <p:nvPr/>
        </p:nvSpPr>
        <p:spPr>
          <a:xfrm>
            <a:off x="2062064" y="5115962"/>
            <a:ext cx="601447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000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2D42A205-E1C0-8A10-8585-23E3B185C9A9}"/>
              </a:ext>
            </a:extLst>
          </p:cNvPr>
          <p:cNvSpPr txBox="1"/>
          <p:nvPr/>
        </p:nvSpPr>
        <p:spPr>
          <a:xfrm>
            <a:off x="2638128" y="5115962"/>
            <a:ext cx="601447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4</a:t>
            </a:r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00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D16DF258-7367-2D30-E117-87B3D5DEC605}"/>
              </a:ext>
            </a:extLst>
          </p:cNvPr>
          <p:cNvSpPr txBox="1"/>
          <p:nvPr/>
        </p:nvSpPr>
        <p:spPr>
          <a:xfrm>
            <a:off x="3260817" y="5115962"/>
            <a:ext cx="601447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6000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26199D41-C93D-CC90-7E71-79153AC8303E}"/>
              </a:ext>
            </a:extLst>
          </p:cNvPr>
          <p:cNvSpPr txBox="1"/>
          <p:nvPr/>
        </p:nvSpPr>
        <p:spPr>
          <a:xfrm>
            <a:off x="3862264" y="5115962"/>
            <a:ext cx="601447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8</a:t>
            </a:r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00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D79A1945-8845-09F0-4A00-42E099516659}"/>
              </a:ext>
            </a:extLst>
          </p:cNvPr>
          <p:cNvSpPr txBox="1"/>
          <p:nvPr/>
        </p:nvSpPr>
        <p:spPr>
          <a:xfrm>
            <a:off x="4380758" y="5115962"/>
            <a:ext cx="70564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0000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511E0DAB-F9D8-2066-BB70-8CC26D7A2A6C}"/>
              </a:ext>
            </a:extLst>
          </p:cNvPr>
          <p:cNvSpPr txBox="1"/>
          <p:nvPr/>
        </p:nvSpPr>
        <p:spPr>
          <a:xfrm>
            <a:off x="5604894" y="5115962"/>
            <a:ext cx="70564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4000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1871508E-D8B2-FC04-1282-968DC108BF72}"/>
              </a:ext>
            </a:extLst>
          </p:cNvPr>
          <p:cNvSpPr txBox="1"/>
          <p:nvPr/>
        </p:nvSpPr>
        <p:spPr>
          <a:xfrm>
            <a:off x="5028830" y="5115962"/>
            <a:ext cx="70564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2000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CFA0B0AB-20B7-2E5D-BC78-D88949EB57FD}"/>
              </a:ext>
            </a:extLst>
          </p:cNvPr>
          <p:cNvSpPr txBox="1"/>
          <p:nvPr/>
        </p:nvSpPr>
        <p:spPr>
          <a:xfrm>
            <a:off x="6252966" y="5115962"/>
            <a:ext cx="70564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6000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8F070F63-7041-10F9-28D6-4F02B1F5FDEC}"/>
              </a:ext>
            </a:extLst>
          </p:cNvPr>
          <p:cNvSpPr txBox="1"/>
          <p:nvPr/>
        </p:nvSpPr>
        <p:spPr>
          <a:xfrm>
            <a:off x="7477102" y="5115962"/>
            <a:ext cx="70564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0</a:t>
            </a:r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00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3F757CF3-9B44-CA35-5972-3A83F2797769}"/>
              </a:ext>
            </a:extLst>
          </p:cNvPr>
          <p:cNvSpPr txBox="1"/>
          <p:nvPr/>
        </p:nvSpPr>
        <p:spPr>
          <a:xfrm>
            <a:off x="8110736" y="5115962"/>
            <a:ext cx="70564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2</a:t>
            </a:r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00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4A045174-7FD4-B473-6492-ACD161639656}"/>
              </a:ext>
            </a:extLst>
          </p:cNvPr>
          <p:cNvSpPr txBox="1"/>
          <p:nvPr/>
        </p:nvSpPr>
        <p:spPr>
          <a:xfrm>
            <a:off x="6890221" y="5115962"/>
            <a:ext cx="70564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8000</a:t>
            </a:r>
            <a:endParaRPr kumimoji="1" lang="ja-JP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69D1EC27-3ED4-1014-39D1-E3E4ED25A613}"/>
              </a:ext>
            </a:extLst>
          </p:cNvPr>
          <p:cNvSpPr txBox="1"/>
          <p:nvPr/>
        </p:nvSpPr>
        <p:spPr>
          <a:xfrm>
            <a:off x="7377011" y="1916832"/>
            <a:ext cx="877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ontrol</a:t>
            </a:r>
            <a:endParaRPr kumimoji="1" lang="ja-JP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5857024A-B148-5A6E-7558-555E81E86903}"/>
              </a:ext>
            </a:extLst>
          </p:cNvPr>
          <p:cNvSpPr txBox="1"/>
          <p:nvPr/>
        </p:nvSpPr>
        <p:spPr>
          <a:xfrm>
            <a:off x="7377011" y="2636912"/>
            <a:ext cx="10061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imonite</a:t>
            </a:r>
            <a:endParaRPr kumimoji="1" lang="ja-JP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3F74D378-CFB4-F508-CCE5-FF4FAC81817F}"/>
              </a:ext>
            </a:extLst>
          </p:cNvPr>
          <p:cNvSpPr txBox="1"/>
          <p:nvPr/>
        </p:nvSpPr>
        <p:spPr>
          <a:xfrm>
            <a:off x="2520280" y="5435932"/>
            <a:ext cx="457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equencing Depth</a:t>
            </a:r>
            <a:endParaRPr lang="ja-JP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4C84B679-31C0-2F5B-D1C7-A00CDEEE3349}"/>
              </a:ext>
            </a:extLst>
          </p:cNvPr>
          <p:cNvSpPr txBox="1"/>
          <p:nvPr/>
        </p:nvSpPr>
        <p:spPr>
          <a:xfrm rot="16200000">
            <a:off x="-885749" y="3332841"/>
            <a:ext cx="248127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Observed OTUs</a:t>
            </a:r>
            <a:endParaRPr lang="ja-JP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12C4E9C9-7217-702F-154C-D1802830A9C2}"/>
              </a:ext>
            </a:extLst>
          </p:cNvPr>
          <p:cNvSpPr txBox="1"/>
          <p:nvPr/>
        </p:nvSpPr>
        <p:spPr>
          <a:xfrm>
            <a:off x="539552" y="648374"/>
            <a:ext cx="832510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100" b="1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Figure</a:t>
            </a:r>
            <a:r>
              <a:rPr lang="en-US" altLang="ja-JP" sz="1100" b="1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S2.</a:t>
            </a:r>
            <a:r>
              <a:rPr lang="ja-JP" altLang="en-US" sz="1100" b="1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　</a:t>
            </a:r>
            <a:endParaRPr lang="ja-JP" altLang="ja-JP" sz="1100" b="1" kern="10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590027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315</TotalTime>
  <Words>77</Words>
  <Application>Microsoft Office PowerPoint</Application>
  <PresentationFormat>On-screen Show (4:3)</PresentationFormat>
  <Paragraphs>41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10" baseType="lpstr">
      <vt:lpstr>游ゴシック</vt:lpstr>
      <vt:lpstr>Aptos</vt:lpstr>
      <vt:lpstr>Aptos Display</vt:lpstr>
      <vt:lpstr>Arial</vt:lpstr>
      <vt:lpstr>Calibri</vt:lpstr>
      <vt:lpstr>Times New Roman</vt:lpstr>
      <vt:lpstr>Office テーマ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3MTLD001</dc:creator>
  <cp:lastModifiedBy>MDPI</cp:lastModifiedBy>
  <cp:revision>75</cp:revision>
  <cp:lastPrinted>2024-06-08T08:06:10Z</cp:lastPrinted>
  <dcterms:created xsi:type="dcterms:W3CDTF">2024-03-22T11:03:52Z</dcterms:created>
  <dcterms:modified xsi:type="dcterms:W3CDTF">2024-07-03T08:49:53Z</dcterms:modified>
</cp:coreProperties>
</file>